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png" ContentType="image/pn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10260013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8698D0-6BB0-4771-ADAA-6D1D1C13CFE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4160" y="410760"/>
            <a:ext cx="617076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4160" y="2393640"/>
            <a:ext cx="6170760" cy="322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4160" y="5929920"/>
            <a:ext cx="6170760" cy="322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45B504-E6D3-41FB-B03E-80EF77AAA3D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4160" y="410760"/>
            <a:ext cx="617076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4160" y="2393640"/>
            <a:ext cx="3011040" cy="322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6040" y="2393640"/>
            <a:ext cx="3011040" cy="322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4160" y="5929920"/>
            <a:ext cx="3011040" cy="322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6040" y="5929920"/>
            <a:ext cx="3011040" cy="322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58A2BD-1CC4-44F3-AE8B-ADE6F9A7F4A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4160" y="410760"/>
            <a:ext cx="617076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4160" y="2393640"/>
            <a:ext cx="1986840" cy="322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30720" y="2393640"/>
            <a:ext cx="1986840" cy="322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7280" y="2393640"/>
            <a:ext cx="1986840" cy="322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4160" y="5929920"/>
            <a:ext cx="1986840" cy="322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30720" y="5929920"/>
            <a:ext cx="1986840" cy="322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7280" y="5929920"/>
            <a:ext cx="1986840" cy="322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B6C6E6-4331-43CD-BACE-16D6B7612BD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4160" y="410760"/>
            <a:ext cx="617076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4160" y="2393640"/>
            <a:ext cx="6170760" cy="6770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7ABF73-7B68-42A2-B320-5F55230248C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4160" y="410760"/>
            <a:ext cx="617076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4160" y="2393640"/>
            <a:ext cx="6170760" cy="6770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595077-045B-4314-875C-2ABDD1569CC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4160" y="410760"/>
            <a:ext cx="617076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4160" y="2393640"/>
            <a:ext cx="3011040" cy="6770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6040" y="2393640"/>
            <a:ext cx="3011040" cy="6770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46E99C-99D0-4F91-9E70-2E5A091CEAD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4160" y="410760"/>
            <a:ext cx="617076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462CC6-EE91-4DB2-864E-C4750F6E5A9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4160" y="410760"/>
            <a:ext cx="6170760" cy="7926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88D608-FD06-4037-AD1A-A046A5F7D82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4160" y="410760"/>
            <a:ext cx="617076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4160" y="2393640"/>
            <a:ext cx="3011040" cy="322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6040" y="2393640"/>
            <a:ext cx="3011040" cy="6770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4160" y="5929920"/>
            <a:ext cx="3011040" cy="322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902B9E-E38C-4E2B-83A7-FFCDE63C7DE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4160" y="410760"/>
            <a:ext cx="617076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4160" y="2393640"/>
            <a:ext cx="3011040" cy="6770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6040" y="2393640"/>
            <a:ext cx="3011040" cy="322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6040" y="5929920"/>
            <a:ext cx="3011040" cy="322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466552-CC14-4638-8A02-B83FE68C17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4160" y="410760"/>
            <a:ext cx="617076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4160" y="2393640"/>
            <a:ext cx="3011040" cy="322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6040" y="2393640"/>
            <a:ext cx="3011040" cy="322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4160" y="5929920"/>
            <a:ext cx="6170760" cy="3229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A45275-B620-4071-BF44-8CEC9B3329F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4160" y="410760"/>
            <a:ext cx="617076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4160" y="2393640"/>
            <a:ext cx="6170760" cy="6770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4160" y="9343800"/>
            <a:ext cx="1598760" cy="711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343800"/>
            <a:ext cx="2171520" cy="711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343800"/>
            <a:ext cx="1600200" cy="711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D270449-98CB-4AEB-A86E-B6486329F57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image" Target="../media/image2.jpe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921960" y="6127920"/>
            <a:ext cx="5113800" cy="344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xpression of Mtss1 splice variants in the early postnatal and adult cerebellum and i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eripheral murine tissues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: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 peripheral organs (K, kidney; S, spleen; T, testis; H, heart, L, lung; G, stomach;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i, small intetine; Sm, skeletal muscle (femur); A, appendix), the exon 11/12/13 Mtss1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variant is expressed. No Mtss1 expression could be detected in the adult forebrain (Fa)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 the forebrain of 8 day old mice (F8), as in adult cerebellum (Cb), both the exo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1/12/13 and the exon 11/12a/13 variants could be detected, with the latter one being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he predominant form. The lower part of the panel shows a ß2-microglobulin loading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ontrol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: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CR amplification of RNA isolated from 8 day old (8) and adult (Ad) cerebellum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using primers located in the 3' part of exon 15 and the 3'UTR, and in exon 14 and th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3'-part of exon 15,  respectively. Note that primers located in exons 14 and 15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lanes labeled "ex14"; primers used: 6, 8) results in two bands of  615 and 660 bp,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dicating that both the 163 and the 208 bp long variants of exon 14 are expressed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Use of primers located in the c-terminal part of exon 15 and the 3'UTR (primers 7, 9;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anes labeled "C-ter") result in one prominent band of 606nt. A very weak band,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igrating close to 550 and 510 respectively, and indicative of the splice variant  of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xon 15 as described in the rat transcript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NSRNOT00000023505, does not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eproduce in this image, but  could just be recognized on the original image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 , mRNA isolated from adult liver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1371600" y="1625760"/>
          <a:ext cx="3584520" cy="12776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3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371600" y="1625760"/>
                    <a:ext cx="3584520" cy="1277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4" name=""/>
          <p:cNvSpPr/>
          <p:nvPr/>
        </p:nvSpPr>
        <p:spPr>
          <a:xfrm>
            <a:off x="1409400" y="1646280"/>
            <a:ext cx="3326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ffffff"/>
                </a:solidFill>
                <a:latin typeface="Arial"/>
              </a:rPr>
              <a:t>K     S     T     H     L     G    Fa    Si     Sm   A      F8   C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4881240" y="2046240"/>
            <a:ext cx="390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5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4881240" y="1846440"/>
            <a:ext cx="390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8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4881240" y="2284560"/>
            <a:ext cx="390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3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4881240" y="2665440"/>
            <a:ext cx="390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3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073160" y="2620800"/>
            <a:ext cx="328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ß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928800" y="11635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" descr=""/>
          <p:cNvPicPr/>
          <p:nvPr/>
        </p:nvPicPr>
        <p:blipFill>
          <a:blip r:embed="rId3"/>
          <a:stretch/>
        </p:blipFill>
        <p:spPr>
          <a:xfrm>
            <a:off x="1373040" y="4219560"/>
            <a:ext cx="2159280" cy="1407960"/>
          </a:xfrm>
          <a:prstGeom prst="rect">
            <a:avLst/>
          </a:prstGeom>
          <a:ln w="0">
            <a:noFill/>
          </a:ln>
        </p:spPr>
      </p:pic>
      <p:sp>
        <p:nvSpPr>
          <p:cNvPr id="52" name=""/>
          <p:cNvSpPr/>
          <p:nvPr/>
        </p:nvSpPr>
        <p:spPr>
          <a:xfrm>
            <a:off x="1052280" y="5307120"/>
            <a:ext cx="390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5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968040" y="439884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100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1755720" y="4230720"/>
            <a:ext cx="17780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ffffff"/>
                </a:solidFill>
                <a:latin typeface="Arial"/>
              </a:rPr>
              <a:t>---- C-ter------   --- ex14 -----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ffffff"/>
                </a:solidFill>
                <a:latin typeface="Arial"/>
              </a:rPr>
              <a:t>  </a:t>
            </a:r>
            <a:r>
              <a:rPr b="1" lang="de-DE" sz="1000" spc="-1" strike="noStrike">
                <a:solidFill>
                  <a:srgbClr val="ffffff"/>
                </a:solidFill>
                <a:latin typeface="Arial"/>
              </a:rPr>
              <a:t>8     Ad    L      8     Ad    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928800" y="376704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772200" y="2014560"/>
            <a:ext cx="67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11/12/1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702360" y="2138400"/>
            <a:ext cx="741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000" spc="-1" strike="noStrike">
                <a:solidFill>
                  <a:srgbClr val="000000"/>
                </a:solidFill>
                <a:latin typeface="Arial"/>
              </a:rPr>
              <a:t>11/12a/1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05-09T13:24:03Z</dcterms:created>
  <dc:creator>Assizimmer</dc:creator>
  <dc:description/>
  <dc:language>en-US</dc:language>
  <cp:lastModifiedBy>Anatomie Bonn</cp:lastModifiedBy>
  <dcterms:modified xsi:type="dcterms:W3CDTF">2007-10-08T14:57:20Z</dcterms:modified>
  <cp:revision>91</cp:revision>
  <dc:subject/>
  <dc:title>Folie 1</dc:title>
</cp:coreProperties>
</file>